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326" r:id="rId2"/>
  </p:sldIdLst>
  <p:sldSz cx="16459200" cy="16459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9373D86-7FCA-5DB1-F926-A274934873CC}" name="Thinzar Lwin" initials="TL" userId="S::thinzar_lwin@dfci.harvard.edu::63edf2e3-fa4c-4084-a286-e357630a55bf" providerId="AD"/>
  <p188:author id="{093161BB-AD84-5701-9EA5-442DD70B3A06}" name="Schnermann, Martin (NIH/NCI) [E]" initials="" userId="S::schnermannmj@nih.gov::c412ead0-a4fe-4cbd-90f4-df425f65cbf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12"/>
    <p:restoredTop sz="78358"/>
  </p:normalViewPr>
  <p:slideViewPr>
    <p:cSldViewPr snapToGrid="0">
      <p:cViewPr>
        <p:scale>
          <a:sx n="50" d="100"/>
          <a:sy n="50" d="100"/>
        </p:scale>
        <p:origin x="24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D9A7F-0694-4944-AB18-09254C04CD9C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FA4288-A46F-5544-BFC7-020A8D6D6D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168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1pPr>
    <a:lvl2pPr marL="658368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2pPr>
    <a:lvl3pPr marL="1316736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3pPr>
    <a:lvl4pPr marL="1975104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4pPr>
    <a:lvl5pPr marL="2633472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5pPr>
    <a:lvl6pPr marL="3291840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6pPr>
    <a:lvl7pPr marL="3950208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7pPr>
    <a:lvl8pPr marL="4608576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8pPr>
    <a:lvl9pPr marL="5266944" algn="l" defTabSz="1316736" rtl="0" eaLnBrk="1" latinLnBrk="0" hangingPunct="1">
      <a:defRPr sz="172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s describing post-hoc analyses of MFI over the tumor (table 1), MFI background (table 2), TBR (table 3), and </a:t>
            </a:r>
            <a:r>
              <a:rPr lang="en-US" dirty="0" err="1"/>
              <a:t>biodistribution</a:t>
            </a:r>
            <a:r>
              <a:rPr lang="en-US" dirty="0"/>
              <a:t> (table 4). 	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1FA4288-A46F-5544-BFC7-020A8D6D6DF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0745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34440" y="2693671"/>
            <a:ext cx="13990320" cy="5730240"/>
          </a:xfrm>
        </p:spPr>
        <p:txBody>
          <a:bodyPr anchor="b"/>
          <a:lstStyle>
            <a:lvl1pPr algn="ctr">
              <a:defRPr sz="10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8644891"/>
            <a:ext cx="12344400" cy="3973829"/>
          </a:xfrm>
        </p:spPr>
        <p:txBody>
          <a:bodyPr/>
          <a:lstStyle>
            <a:lvl1pPr marL="0" indent="0" algn="ctr">
              <a:buNone/>
              <a:defRPr sz="4320"/>
            </a:lvl1pPr>
            <a:lvl2pPr marL="822960" indent="0" algn="ctr">
              <a:buNone/>
              <a:defRPr sz="3600"/>
            </a:lvl2pPr>
            <a:lvl3pPr marL="1645920" indent="0" algn="ctr">
              <a:buNone/>
              <a:defRPr sz="3240"/>
            </a:lvl3pPr>
            <a:lvl4pPr marL="2468880" indent="0" algn="ctr">
              <a:buNone/>
              <a:defRPr sz="2880"/>
            </a:lvl4pPr>
            <a:lvl5pPr marL="3291840" indent="0" algn="ctr">
              <a:buNone/>
              <a:defRPr sz="2880"/>
            </a:lvl5pPr>
            <a:lvl6pPr marL="4114800" indent="0" algn="ctr">
              <a:buNone/>
              <a:defRPr sz="2880"/>
            </a:lvl6pPr>
            <a:lvl7pPr marL="4937760" indent="0" algn="ctr">
              <a:buNone/>
              <a:defRPr sz="2880"/>
            </a:lvl7pPr>
            <a:lvl8pPr marL="5760720" indent="0" algn="ctr">
              <a:buNone/>
              <a:defRPr sz="2880"/>
            </a:lvl8pPr>
            <a:lvl9pPr marL="6583680" indent="0" algn="ctr">
              <a:buNone/>
              <a:defRPr sz="28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647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108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778616" y="876300"/>
            <a:ext cx="3549015" cy="1394841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1571" y="876300"/>
            <a:ext cx="10441305" cy="1394841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380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81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2998" y="4103375"/>
            <a:ext cx="14196060" cy="6846569"/>
          </a:xfrm>
        </p:spPr>
        <p:txBody>
          <a:bodyPr anchor="b"/>
          <a:lstStyle>
            <a:lvl1pPr>
              <a:defRPr sz="10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2998" y="11014715"/>
            <a:ext cx="14196060" cy="3600449"/>
          </a:xfrm>
        </p:spPr>
        <p:txBody>
          <a:bodyPr/>
          <a:lstStyle>
            <a:lvl1pPr marL="0" indent="0">
              <a:buNone/>
              <a:defRPr sz="4320">
                <a:solidFill>
                  <a:schemeClr val="tx1">
                    <a:tint val="82000"/>
                  </a:schemeClr>
                </a:solidFill>
              </a:defRPr>
            </a:lvl1pPr>
            <a:lvl2pPr marL="822960" indent="0">
              <a:buNone/>
              <a:defRPr sz="3600">
                <a:solidFill>
                  <a:schemeClr val="tx1">
                    <a:tint val="82000"/>
                  </a:schemeClr>
                </a:solidFill>
              </a:defRPr>
            </a:lvl2pPr>
            <a:lvl3pPr marL="1645920" indent="0">
              <a:buNone/>
              <a:defRPr sz="3240">
                <a:solidFill>
                  <a:schemeClr val="tx1">
                    <a:tint val="82000"/>
                  </a:schemeClr>
                </a:solidFill>
              </a:defRPr>
            </a:lvl3pPr>
            <a:lvl4pPr marL="2468880" indent="0">
              <a:buNone/>
              <a:defRPr sz="2880">
                <a:solidFill>
                  <a:schemeClr val="tx1">
                    <a:tint val="82000"/>
                  </a:schemeClr>
                </a:solidFill>
              </a:defRPr>
            </a:lvl4pPr>
            <a:lvl5pPr marL="3291840" indent="0">
              <a:buNone/>
              <a:defRPr sz="2880">
                <a:solidFill>
                  <a:schemeClr val="tx1">
                    <a:tint val="82000"/>
                  </a:schemeClr>
                </a:solidFill>
              </a:defRPr>
            </a:lvl5pPr>
            <a:lvl6pPr marL="4114800" indent="0">
              <a:buNone/>
              <a:defRPr sz="2880">
                <a:solidFill>
                  <a:schemeClr val="tx1">
                    <a:tint val="82000"/>
                  </a:schemeClr>
                </a:solidFill>
              </a:defRPr>
            </a:lvl6pPr>
            <a:lvl7pPr marL="4937760" indent="0">
              <a:buNone/>
              <a:defRPr sz="2880">
                <a:solidFill>
                  <a:schemeClr val="tx1">
                    <a:tint val="82000"/>
                  </a:schemeClr>
                </a:solidFill>
              </a:defRPr>
            </a:lvl7pPr>
            <a:lvl8pPr marL="5760720" indent="0">
              <a:buNone/>
              <a:defRPr sz="2880">
                <a:solidFill>
                  <a:schemeClr val="tx1">
                    <a:tint val="82000"/>
                  </a:schemeClr>
                </a:solidFill>
              </a:defRPr>
            </a:lvl8pPr>
            <a:lvl9pPr marL="6583680" indent="0">
              <a:buNone/>
              <a:defRPr sz="28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91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1570" y="4381500"/>
            <a:ext cx="6995160" cy="104432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32470" y="4381500"/>
            <a:ext cx="6995160" cy="104432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098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876304"/>
            <a:ext cx="14196060" cy="318135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3716" y="4034791"/>
            <a:ext cx="6963012" cy="1977389"/>
          </a:xfrm>
        </p:spPr>
        <p:txBody>
          <a:bodyPr anchor="b"/>
          <a:lstStyle>
            <a:lvl1pPr marL="0" indent="0">
              <a:buNone/>
              <a:defRPr sz="432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40" b="1"/>
            </a:lvl3pPr>
            <a:lvl4pPr marL="2468880" indent="0">
              <a:buNone/>
              <a:defRPr sz="2880" b="1"/>
            </a:lvl4pPr>
            <a:lvl5pPr marL="3291840" indent="0">
              <a:buNone/>
              <a:defRPr sz="2880" b="1"/>
            </a:lvl5pPr>
            <a:lvl6pPr marL="4114800" indent="0">
              <a:buNone/>
              <a:defRPr sz="2880" b="1"/>
            </a:lvl6pPr>
            <a:lvl7pPr marL="4937760" indent="0">
              <a:buNone/>
              <a:defRPr sz="2880" b="1"/>
            </a:lvl7pPr>
            <a:lvl8pPr marL="5760720" indent="0">
              <a:buNone/>
              <a:defRPr sz="2880" b="1"/>
            </a:lvl8pPr>
            <a:lvl9pPr marL="6583680" indent="0">
              <a:buNone/>
              <a:defRPr sz="28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33716" y="6012180"/>
            <a:ext cx="6963012" cy="88430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32471" y="4034791"/>
            <a:ext cx="6997304" cy="1977389"/>
          </a:xfrm>
        </p:spPr>
        <p:txBody>
          <a:bodyPr anchor="b"/>
          <a:lstStyle>
            <a:lvl1pPr marL="0" indent="0">
              <a:buNone/>
              <a:defRPr sz="432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40" b="1"/>
            </a:lvl3pPr>
            <a:lvl4pPr marL="2468880" indent="0">
              <a:buNone/>
              <a:defRPr sz="2880" b="1"/>
            </a:lvl4pPr>
            <a:lvl5pPr marL="3291840" indent="0">
              <a:buNone/>
              <a:defRPr sz="2880" b="1"/>
            </a:lvl5pPr>
            <a:lvl6pPr marL="4114800" indent="0">
              <a:buNone/>
              <a:defRPr sz="2880" b="1"/>
            </a:lvl6pPr>
            <a:lvl7pPr marL="4937760" indent="0">
              <a:buNone/>
              <a:defRPr sz="2880" b="1"/>
            </a:lvl7pPr>
            <a:lvl8pPr marL="5760720" indent="0">
              <a:buNone/>
              <a:defRPr sz="2880" b="1"/>
            </a:lvl8pPr>
            <a:lvl9pPr marL="6583680" indent="0">
              <a:buNone/>
              <a:defRPr sz="28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32471" y="6012180"/>
            <a:ext cx="6997304" cy="88430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136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450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144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1097280"/>
            <a:ext cx="5308520" cy="3840480"/>
          </a:xfrm>
        </p:spPr>
        <p:txBody>
          <a:bodyPr anchor="b"/>
          <a:lstStyle>
            <a:lvl1pPr>
              <a:defRPr sz="5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97304" y="2369824"/>
            <a:ext cx="8332470" cy="11696700"/>
          </a:xfrm>
        </p:spPr>
        <p:txBody>
          <a:bodyPr/>
          <a:lstStyle>
            <a:lvl1pPr>
              <a:defRPr sz="5760"/>
            </a:lvl1pPr>
            <a:lvl2pPr>
              <a:defRPr sz="5040"/>
            </a:lvl2pPr>
            <a:lvl3pPr>
              <a:defRPr sz="432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4937760"/>
            <a:ext cx="5308520" cy="9147811"/>
          </a:xfrm>
        </p:spPr>
        <p:txBody>
          <a:bodyPr/>
          <a:lstStyle>
            <a:lvl1pPr marL="0" indent="0">
              <a:buNone/>
              <a:defRPr sz="2880"/>
            </a:lvl1pPr>
            <a:lvl2pPr marL="822960" indent="0">
              <a:buNone/>
              <a:defRPr sz="2520"/>
            </a:lvl2pPr>
            <a:lvl3pPr marL="1645920" indent="0">
              <a:buNone/>
              <a:defRPr sz="2160"/>
            </a:lvl3pPr>
            <a:lvl4pPr marL="2468880" indent="0">
              <a:buNone/>
              <a:defRPr sz="1800"/>
            </a:lvl4pPr>
            <a:lvl5pPr marL="3291840" indent="0">
              <a:buNone/>
              <a:defRPr sz="1800"/>
            </a:lvl5pPr>
            <a:lvl6pPr marL="4114800" indent="0">
              <a:buNone/>
              <a:defRPr sz="1800"/>
            </a:lvl6pPr>
            <a:lvl7pPr marL="4937760" indent="0">
              <a:buNone/>
              <a:defRPr sz="1800"/>
            </a:lvl7pPr>
            <a:lvl8pPr marL="5760720" indent="0">
              <a:buNone/>
              <a:defRPr sz="1800"/>
            </a:lvl8pPr>
            <a:lvl9pPr marL="658368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40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1097280"/>
            <a:ext cx="5308520" cy="3840480"/>
          </a:xfrm>
        </p:spPr>
        <p:txBody>
          <a:bodyPr anchor="b"/>
          <a:lstStyle>
            <a:lvl1pPr>
              <a:defRPr sz="5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97304" y="2369824"/>
            <a:ext cx="8332470" cy="11696700"/>
          </a:xfrm>
        </p:spPr>
        <p:txBody>
          <a:bodyPr anchor="t"/>
          <a:lstStyle>
            <a:lvl1pPr marL="0" indent="0">
              <a:buNone/>
              <a:defRPr sz="5760"/>
            </a:lvl1pPr>
            <a:lvl2pPr marL="822960" indent="0">
              <a:buNone/>
              <a:defRPr sz="5040"/>
            </a:lvl2pPr>
            <a:lvl3pPr marL="1645920" indent="0">
              <a:buNone/>
              <a:defRPr sz="4320"/>
            </a:lvl3pPr>
            <a:lvl4pPr marL="2468880" indent="0">
              <a:buNone/>
              <a:defRPr sz="3600"/>
            </a:lvl4pPr>
            <a:lvl5pPr marL="3291840" indent="0">
              <a:buNone/>
              <a:defRPr sz="3600"/>
            </a:lvl5pPr>
            <a:lvl6pPr marL="4114800" indent="0">
              <a:buNone/>
              <a:defRPr sz="3600"/>
            </a:lvl6pPr>
            <a:lvl7pPr marL="4937760" indent="0">
              <a:buNone/>
              <a:defRPr sz="3600"/>
            </a:lvl7pPr>
            <a:lvl8pPr marL="5760720" indent="0">
              <a:buNone/>
              <a:defRPr sz="3600"/>
            </a:lvl8pPr>
            <a:lvl9pPr marL="6583680" indent="0">
              <a:buNone/>
              <a:defRPr sz="3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4937760"/>
            <a:ext cx="5308520" cy="9147811"/>
          </a:xfrm>
        </p:spPr>
        <p:txBody>
          <a:bodyPr/>
          <a:lstStyle>
            <a:lvl1pPr marL="0" indent="0">
              <a:buNone/>
              <a:defRPr sz="2880"/>
            </a:lvl1pPr>
            <a:lvl2pPr marL="822960" indent="0">
              <a:buNone/>
              <a:defRPr sz="2520"/>
            </a:lvl2pPr>
            <a:lvl3pPr marL="1645920" indent="0">
              <a:buNone/>
              <a:defRPr sz="2160"/>
            </a:lvl3pPr>
            <a:lvl4pPr marL="2468880" indent="0">
              <a:buNone/>
              <a:defRPr sz="1800"/>
            </a:lvl4pPr>
            <a:lvl5pPr marL="3291840" indent="0">
              <a:buNone/>
              <a:defRPr sz="1800"/>
            </a:lvl5pPr>
            <a:lvl6pPr marL="4114800" indent="0">
              <a:buNone/>
              <a:defRPr sz="1800"/>
            </a:lvl6pPr>
            <a:lvl7pPr marL="4937760" indent="0">
              <a:buNone/>
              <a:defRPr sz="1800"/>
            </a:lvl7pPr>
            <a:lvl8pPr marL="5760720" indent="0">
              <a:buNone/>
              <a:defRPr sz="1800"/>
            </a:lvl8pPr>
            <a:lvl9pPr marL="658368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072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1570" y="876304"/>
            <a:ext cx="14196060" cy="31813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1570" y="4381500"/>
            <a:ext cx="14196060" cy="10443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1570" y="15255244"/>
            <a:ext cx="370332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D3CFCE1-571D-334F-BDD6-ACF51AD0B38E}" type="datetimeFigureOut">
              <a:rPr lang="en-US" smtClean="0"/>
              <a:t>2/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52110" y="15255244"/>
            <a:ext cx="555498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24310" y="15255244"/>
            <a:ext cx="370332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3CE23B-83F8-4A44-A818-0AB40E6A31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990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45920" rtl="0" eaLnBrk="1" latinLnBrk="0" hangingPunct="1">
        <a:lnSpc>
          <a:spcPct val="90000"/>
        </a:lnSpc>
        <a:spcBef>
          <a:spcPct val="0"/>
        </a:spcBef>
        <a:buNone/>
        <a:defRPr sz="79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1480" indent="-411480" algn="l" defTabSz="164592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1pPr>
      <a:lvl2pPr marL="123444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4320" kern="1200">
          <a:solidFill>
            <a:schemeClr val="tx1"/>
          </a:solidFill>
          <a:latin typeface="+mn-lt"/>
          <a:ea typeface="+mn-ea"/>
          <a:cs typeface="+mn-cs"/>
        </a:defRPr>
      </a:lvl2pPr>
      <a:lvl3pPr marL="205740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88036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4pPr>
      <a:lvl5pPr marL="370332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5pPr>
      <a:lvl6pPr marL="452628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6pPr>
      <a:lvl7pPr marL="534924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7pPr>
      <a:lvl8pPr marL="617220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8pPr>
      <a:lvl9pPr marL="699516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2pPr>
      <a:lvl3pPr marL="164592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3pPr>
      <a:lvl4pPr marL="246888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5pPr>
      <a:lvl6pPr marL="411480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6pPr>
      <a:lvl7pPr marL="493776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7pPr>
      <a:lvl8pPr marL="576072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8pPr>
      <a:lvl9pPr marL="658368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8747970-187B-39E6-9FF0-B17959149D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2491632"/>
              </p:ext>
            </p:extLst>
          </p:nvPr>
        </p:nvGraphicFramePr>
        <p:xfrm>
          <a:off x="944223" y="1178248"/>
          <a:ext cx="6214860" cy="4017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30148">
                  <a:extLst>
                    <a:ext uri="{9D8B030D-6E8A-4147-A177-3AD203B41FA5}">
                      <a16:colId xmlns:a16="http://schemas.microsoft.com/office/drawing/2014/main" val="4241902217"/>
                    </a:ext>
                  </a:extLst>
                </a:gridCol>
                <a:gridCol w="2111828">
                  <a:extLst>
                    <a:ext uri="{9D8B030D-6E8A-4147-A177-3AD203B41FA5}">
                      <a16:colId xmlns:a16="http://schemas.microsoft.com/office/drawing/2014/main" val="4072099781"/>
                    </a:ext>
                  </a:extLst>
                </a:gridCol>
                <a:gridCol w="608628">
                  <a:extLst>
                    <a:ext uri="{9D8B030D-6E8A-4147-A177-3AD203B41FA5}">
                      <a16:colId xmlns:a16="http://schemas.microsoft.com/office/drawing/2014/main" val="397122091"/>
                    </a:ext>
                  </a:extLst>
                </a:gridCol>
                <a:gridCol w="1321152">
                  <a:extLst>
                    <a:ext uri="{9D8B030D-6E8A-4147-A177-3AD203B41FA5}">
                      <a16:colId xmlns:a16="http://schemas.microsoft.com/office/drawing/2014/main" val="43192583"/>
                    </a:ext>
                  </a:extLst>
                </a:gridCol>
                <a:gridCol w="392861">
                  <a:extLst>
                    <a:ext uri="{9D8B030D-6E8A-4147-A177-3AD203B41FA5}">
                      <a16:colId xmlns:a16="http://schemas.microsoft.com/office/drawing/2014/main" val="2308931538"/>
                    </a:ext>
                  </a:extLst>
                </a:gridCol>
                <a:gridCol w="620548">
                  <a:extLst>
                    <a:ext uri="{9D8B030D-6E8A-4147-A177-3AD203B41FA5}">
                      <a16:colId xmlns:a16="http://schemas.microsoft.com/office/drawing/2014/main" val="52411571"/>
                    </a:ext>
                  </a:extLst>
                </a:gridCol>
                <a:gridCol w="629695">
                  <a:extLst>
                    <a:ext uri="{9D8B030D-6E8A-4147-A177-3AD203B41FA5}">
                      <a16:colId xmlns:a16="http://schemas.microsoft.com/office/drawing/2014/main" val="360397535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point (hr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 ANOVA with Tukey's multiple comparisons tes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 diff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0% CI of diff.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owthreshold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?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mar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 P 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1322501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5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8639 to 0.016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347489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0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938 to 0.192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7301825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65 to 0.23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2267069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547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875 to 0.178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84117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5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25 to 0.908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779215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12 to 0.998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1553022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4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76 to -0.20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7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399095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999 to 0.869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6827995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68 to 1.59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0980185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849 to -0.63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679183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83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293 to 0.686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4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669285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98 to 1.9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4193900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71 to -0.68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92434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467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908 to 0.497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883311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84 to 1.7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493036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4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818 to -0.669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934566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7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507 to 0.39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9943082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31 to 1.6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6505460"/>
                  </a:ext>
                </a:extLst>
              </a:tr>
            </a:tbl>
          </a:graphicData>
        </a:graphic>
      </p:graphicFrame>
      <p:sp>
        <p:nvSpPr>
          <p:cNvPr id="5" name="Google Shape;293;g3404cd86b8d_0_1">
            <a:extLst>
              <a:ext uri="{FF2B5EF4-FFF2-40B4-BE49-F238E27FC236}">
                <a16:creationId xmlns:a16="http://schemas.microsoft.com/office/drawing/2014/main" id="{7BFD3951-1D77-150C-9BC0-A972497AA444}"/>
              </a:ext>
            </a:extLst>
          </p:cNvPr>
          <p:cNvSpPr txBox="1"/>
          <p:nvPr/>
        </p:nvSpPr>
        <p:spPr>
          <a:xfrm>
            <a:off x="944223" y="228600"/>
            <a:ext cx="11830200" cy="1491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02850" tIns="51425" rIns="102850" bIns="51425" anchor="ctr" anchorCtr="0">
            <a:normAutofit/>
          </a:bodyPr>
          <a:lstStyle/>
          <a:p>
            <a:pPr>
              <a:lnSpc>
                <a:spcPct val="90000"/>
              </a:lnSpc>
              <a:buClr>
                <a:schemeClr val="dk1"/>
              </a:buClr>
              <a:buSzPts val="4950"/>
            </a:pPr>
            <a:r>
              <a:rPr lang="en-US" sz="2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Table 1 (MFI Tumor)</a:t>
            </a:r>
            <a:endParaRPr sz="2000" dirty="0"/>
          </a:p>
        </p:txBody>
      </p:sp>
      <p:sp>
        <p:nvSpPr>
          <p:cNvPr id="6" name="Google Shape;293;g3404cd86b8d_0_1">
            <a:extLst>
              <a:ext uri="{FF2B5EF4-FFF2-40B4-BE49-F238E27FC236}">
                <a16:creationId xmlns:a16="http://schemas.microsoft.com/office/drawing/2014/main" id="{77F2E412-119D-1058-0EA0-2C369D4A314B}"/>
              </a:ext>
            </a:extLst>
          </p:cNvPr>
          <p:cNvSpPr txBox="1"/>
          <p:nvPr/>
        </p:nvSpPr>
        <p:spPr>
          <a:xfrm>
            <a:off x="9113572" y="0"/>
            <a:ext cx="11830200" cy="1491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02850" tIns="51425" rIns="102850" bIns="51425" anchor="ctr" anchorCtr="0">
            <a:normAutofit/>
          </a:bodyPr>
          <a:lstStyle/>
          <a:p>
            <a:pPr>
              <a:lnSpc>
                <a:spcPct val="90000"/>
              </a:lnSpc>
              <a:buClr>
                <a:schemeClr val="dk1"/>
              </a:buClr>
              <a:buSzPts val="4950"/>
            </a:pPr>
            <a:r>
              <a:rPr lang="en-US" sz="2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Table 2 (MFI Background)</a:t>
            </a:r>
            <a:endParaRPr sz="2000" dirty="0"/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23333122-B704-0410-4F12-C899AF4673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413505"/>
              </p:ext>
            </p:extLst>
          </p:nvPr>
        </p:nvGraphicFramePr>
        <p:xfrm>
          <a:off x="8857955" y="1178247"/>
          <a:ext cx="6143920" cy="4017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46480">
                  <a:extLst>
                    <a:ext uri="{9D8B030D-6E8A-4147-A177-3AD203B41FA5}">
                      <a16:colId xmlns:a16="http://schemas.microsoft.com/office/drawing/2014/main" val="472180850"/>
                    </a:ext>
                  </a:extLst>
                </a:gridCol>
                <a:gridCol w="2118405">
                  <a:extLst>
                    <a:ext uri="{9D8B030D-6E8A-4147-A177-3AD203B41FA5}">
                      <a16:colId xmlns:a16="http://schemas.microsoft.com/office/drawing/2014/main" val="3586809254"/>
                    </a:ext>
                  </a:extLst>
                </a:gridCol>
                <a:gridCol w="674470">
                  <a:extLst>
                    <a:ext uri="{9D8B030D-6E8A-4147-A177-3AD203B41FA5}">
                      <a16:colId xmlns:a16="http://schemas.microsoft.com/office/drawing/2014/main" val="283220413"/>
                    </a:ext>
                  </a:extLst>
                </a:gridCol>
                <a:gridCol w="1320441">
                  <a:extLst>
                    <a:ext uri="{9D8B030D-6E8A-4147-A177-3AD203B41FA5}">
                      <a16:colId xmlns:a16="http://schemas.microsoft.com/office/drawing/2014/main" val="3286698883"/>
                    </a:ext>
                  </a:extLst>
                </a:gridCol>
                <a:gridCol w="392649">
                  <a:extLst>
                    <a:ext uri="{9D8B030D-6E8A-4147-A177-3AD203B41FA5}">
                      <a16:colId xmlns:a16="http://schemas.microsoft.com/office/drawing/2014/main" val="3857883601"/>
                    </a:ext>
                  </a:extLst>
                </a:gridCol>
                <a:gridCol w="627119">
                  <a:extLst>
                    <a:ext uri="{9D8B030D-6E8A-4147-A177-3AD203B41FA5}">
                      <a16:colId xmlns:a16="http://schemas.microsoft.com/office/drawing/2014/main" val="3127035366"/>
                    </a:ext>
                  </a:extLst>
                </a:gridCol>
                <a:gridCol w="564356">
                  <a:extLst>
                    <a:ext uri="{9D8B030D-6E8A-4147-A177-3AD203B41FA5}">
                      <a16:colId xmlns:a16="http://schemas.microsoft.com/office/drawing/2014/main" val="180723697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point (hr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 ANOVA with Tukey's multiple comparisons tes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 diff.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0% CI of diff.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owthreshold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?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mary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 P 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34681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547 to 0.0549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366166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5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05 to 0.22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9775590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37 to 0.218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7409971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49 to 0.776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1741992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69 to 1.0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985374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03 to 0.429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8871666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8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839 to 0.095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228873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1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44 to 0.348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5592975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2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77 to 0.307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2006262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9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995 to -0.086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4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97502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46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174 to 0.20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5163854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45 to 0.39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492964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871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467 to -0.0275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3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351688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93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026 to 0.0889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1410015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76 to 0.18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6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3706754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3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846 to -0.088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9935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3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113 to 0.034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569534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236 to 0.17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2069139"/>
                  </a:ext>
                </a:extLst>
              </a:tr>
            </a:tbl>
          </a:graphicData>
        </a:graphic>
      </p:graphicFrame>
      <p:sp>
        <p:nvSpPr>
          <p:cNvPr id="8" name="Google Shape;293;g3404cd86b8d_0_1">
            <a:extLst>
              <a:ext uri="{FF2B5EF4-FFF2-40B4-BE49-F238E27FC236}">
                <a16:creationId xmlns:a16="http://schemas.microsoft.com/office/drawing/2014/main" id="{889A0DA2-D8BE-107A-0C1F-7938C4449B38}"/>
              </a:ext>
            </a:extLst>
          </p:cNvPr>
          <p:cNvSpPr txBox="1"/>
          <p:nvPr/>
        </p:nvSpPr>
        <p:spPr>
          <a:xfrm>
            <a:off x="944223" y="5814652"/>
            <a:ext cx="11830200" cy="1491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02850" tIns="51425" rIns="102850" bIns="51425" anchor="ctr" anchorCtr="0">
            <a:normAutofit/>
          </a:bodyPr>
          <a:lstStyle/>
          <a:p>
            <a:pPr>
              <a:lnSpc>
                <a:spcPct val="90000"/>
              </a:lnSpc>
              <a:buClr>
                <a:schemeClr val="dk1"/>
              </a:buClr>
              <a:buSzPts val="4950"/>
            </a:pPr>
            <a:r>
              <a:rPr lang="en-US" sz="2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Table 3 (TBR)</a:t>
            </a:r>
            <a:endParaRPr sz="2000" dirty="0"/>
          </a:p>
        </p:txBody>
      </p:sp>
      <p:sp>
        <p:nvSpPr>
          <p:cNvPr id="9" name="Google Shape;293;g3404cd86b8d_0_1">
            <a:extLst>
              <a:ext uri="{FF2B5EF4-FFF2-40B4-BE49-F238E27FC236}">
                <a16:creationId xmlns:a16="http://schemas.microsoft.com/office/drawing/2014/main" id="{289E8503-1DCC-E6E0-D935-CC747D2B157F}"/>
              </a:ext>
            </a:extLst>
          </p:cNvPr>
          <p:cNvSpPr txBox="1"/>
          <p:nvPr/>
        </p:nvSpPr>
        <p:spPr>
          <a:xfrm>
            <a:off x="9113572" y="5814652"/>
            <a:ext cx="11830200" cy="1491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02850" tIns="51425" rIns="102850" bIns="51425" anchor="ctr" anchorCtr="0">
            <a:normAutofit/>
          </a:bodyPr>
          <a:lstStyle/>
          <a:p>
            <a:pPr>
              <a:lnSpc>
                <a:spcPct val="90000"/>
              </a:lnSpc>
              <a:buClr>
                <a:schemeClr val="dk1"/>
              </a:buClr>
              <a:buSzPts val="4950"/>
            </a:pPr>
            <a:r>
              <a:rPr lang="en-US" sz="2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Table 4 (Biodistribution)</a:t>
            </a:r>
            <a:endParaRPr sz="2000" dirty="0"/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D350D18D-CEDD-1733-BCC5-63CB998AA7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334453"/>
              </p:ext>
            </p:extLst>
          </p:nvPr>
        </p:nvGraphicFramePr>
        <p:xfrm>
          <a:off x="950572" y="7144426"/>
          <a:ext cx="6241965" cy="40176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46480">
                  <a:extLst>
                    <a:ext uri="{9D8B030D-6E8A-4147-A177-3AD203B41FA5}">
                      <a16:colId xmlns:a16="http://schemas.microsoft.com/office/drawing/2014/main" val="2841598416"/>
                    </a:ext>
                  </a:extLst>
                </a:gridCol>
                <a:gridCol w="2118405">
                  <a:extLst>
                    <a:ext uri="{9D8B030D-6E8A-4147-A177-3AD203B41FA5}">
                      <a16:colId xmlns:a16="http://schemas.microsoft.com/office/drawing/2014/main" val="3876110442"/>
                    </a:ext>
                  </a:extLst>
                </a:gridCol>
                <a:gridCol w="674470">
                  <a:extLst>
                    <a:ext uri="{9D8B030D-6E8A-4147-A177-3AD203B41FA5}">
                      <a16:colId xmlns:a16="http://schemas.microsoft.com/office/drawing/2014/main" val="1780613932"/>
                    </a:ext>
                  </a:extLst>
                </a:gridCol>
                <a:gridCol w="1320441">
                  <a:extLst>
                    <a:ext uri="{9D8B030D-6E8A-4147-A177-3AD203B41FA5}">
                      <a16:colId xmlns:a16="http://schemas.microsoft.com/office/drawing/2014/main" val="3951462159"/>
                    </a:ext>
                  </a:extLst>
                </a:gridCol>
                <a:gridCol w="392649">
                  <a:extLst>
                    <a:ext uri="{9D8B030D-6E8A-4147-A177-3AD203B41FA5}">
                      <a16:colId xmlns:a16="http://schemas.microsoft.com/office/drawing/2014/main" val="4177618297"/>
                    </a:ext>
                  </a:extLst>
                </a:gridCol>
                <a:gridCol w="665051">
                  <a:extLst>
                    <a:ext uri="{9D8B030D-6E8A-4147-A177-3AD203B41FA5}">
                      <a16:colId xmlns:a16="http://schemas.microsoft.com/office/drawing/2014/main" val="625152747"/>
                    </a:ext>
                  </a:extLst>
                </a:gridCol>
                <a:gridCol w="624469">
                  <a:extLst>
                    <a:ext uri="{9D8B030D-6E8A-4147-A177-3AD203B41FA5}">
                      <a16:colId xmlns:a16="http://schemas.microsoft.com/office/drawing/2014/main" val="101498713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point (hr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 ANOVA with Tukey's multiple comparisons tes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 diff.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0% CI of diff.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ow threshold?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mary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 P 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1007357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27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119 to -0.043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471213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944 to 0.0743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0775986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539 to 0.33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2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6560058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0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393 to -1.7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819724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8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23 to -0.939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*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9880466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59 to 1.16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5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708731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4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052 to -0.84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4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42885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389 to -0.184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69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2011749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911 to 2.21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2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6873886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3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506 to -0.13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57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057271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03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223 to 0.145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8368397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836 to 2.4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0460918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.4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1.84 to -0.99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3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242984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8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.233 to 2.6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0194173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86 to 9.40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3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8485812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6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878 to 0.53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955941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9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.148 to 2.26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7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992638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766 vs. M5A-FNIR-8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766 to 6.22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185571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96FD1E06-2B1E-7752-6A5E-000FCB931C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3599041"/>
              </p:ext>
            </p:extLst>
          </p:nvPr>
        </p:nvGraphicFramePr>
        <p:xfrm>
          <a:off x="8857955" y="7144426"/>
          <a:ext cx="6631089" cy="57245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7188">
                  <a:extLst>
                    <a:ext uri="{9D8B030D-6E8A-4147-A177-3AD203B41FA5}">
                      <a16:colId xmlns:a16="http://schemas.microsoft.com/office/drawing/2014/main" val="661337056"/>
                    </a:ext>
                  </a:extLst>
                </a:gridCol>
                <a:gridCol w="2158830">
                  <a:extLst>
                    <a:ext uri="{9D8B030D-6E8A-4147-A177-3AD203B41FA5}">
                      <a16:colId xmlns:a16="http://schemas.microsoft.com/office/drawing/2014/main" val="2603609919"/>
                    </a:ext>
                  </a:extLst>
                </a:gridCol>
                <a:gridCol w="675229">
                  <a:extLst>
                    <a:ext uri="{9D8B030D-6E8A-4147-A177-3AD203B41FA5}">
                      <a16:colId xmlns:a16="http://schemas.microsoft.com/office/drawing/2014/main" val="865692263"/>
                    </a:ext>
                  </a:extLst>
                </a:gridCol>
                <a:gridCol w="1445560">
                  <a:extLst>
                    <a:ext uri="{9D8B030D-6E8A-4147-A177-3AD203B41FA5}">
                      <a16:colId xmlns:a16="http://schemas.microsoft.com/office/drawing/2014/main" val="604401531"/>
                    </a:ext>
                  </a:extLst>
                </a:gridCol>
                <a:gridCol w="427013">
                  <a:extLst>
                    <a:ext uri="{9D8B030D-6E8A-4147-A177-3AD203B41FA5}">
                      <a16:colId xmlns:a16="http://schemas.microsoft.com/office/drawing/2014/main" val="3538618782"/>
                    </a:ext>
                  </a:extLst>
                </a:gridCol>
                <a:gridCol w="651649">
                  <a:extLst>
                    <a:ext uri="{9D8B030D-6E8A-4147-A177-3AD203B41FA5}">
                      <a16:colId xmlns:a16="http://schemas.microsoft.com/office/drawing/2014/main" val="1403883627"/>
                    </a:ext>
                  </a:extLst>
                </a:gridCol>
                <a:gridCol w="635620">
                  <a:extLst>
                    <a:ext uri="{9D8B030D-6E8A-4147-A177-3AD203B41FA5}">
                      <a16:colId xmlns:a16="http://schemas.microsoft.com/office/drawing/2014/main" val="520963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1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 ANOVA with Tukey's multiple comparisons test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 diff.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0% CI of diff.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ow threshold?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mary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 P 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3050976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88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831 to 0.60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197735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945 to -0.355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7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7091095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6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25 to -0.198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9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9123940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omac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47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279 to 0.0422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568598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18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935 to 0.025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034544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6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4300 to 0.0098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7263418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e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2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043 to 0.0663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798651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61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746 to -0.0177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4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729073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84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594 to -0.0088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75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5355641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rea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17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528 to 0.0276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681725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75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5405 to -0.00113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03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5032306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87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5419 to -0.00335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4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6444509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8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244 to 0.094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8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304668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7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726 to 0.0547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5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065909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431 to -0.0050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35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8339272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cu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8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7352 to 0.027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339838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53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255 to 0.0119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8769506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175 to 0.00134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381306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8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75 to 0.828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430493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24 to 0.743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0457191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85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739 to 0.20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1452515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7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047 to 0.0340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118422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1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5897 to -0.00445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5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7001237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6469 to -0.012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403992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a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8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7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596 to 0.037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310695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IR800CW vs. M5A-FNIR-7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8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500 to -0.0016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01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1801796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 M5A-FNIR-804 vs. M5A-FNIR-7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39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430 to -0.00378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89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71544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48345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894</TotalTime>
  <Words>1747</Words>
  <Application>Microsoft Office PowerPoint</Application>
  <PresentationFormat>Custom</PresentationFormat>
  <Paragraphs>54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inzar Lwin</dc:creator>
  <cp:lastModifiedBy>Charline Montemayor</cp:lastModifiedBy>
  <cp:revision>114</cp:revision>
  <dcterms:created xsi:type="dcterms:W3CDTF">2025-01-08T00:32:00Z</dcterms:created>
  <dcterms:modified xsi:type="dcterms:W3CDTF">2026-02-01T11:35:31Z</dcterms:modified>
</cp:coreProperties>
</file>